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771A06-99EC-4CB5-BF4B-62476D79D4E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8A1A7F-5DA3-44FB-935C-F4C0C3B2EA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CA65A0-5744-477D-8F5C-9668599DC16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43BC30-660B-4E82-9C6B-3E6BC7BE48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ABE150-A58D-4102-9D95-1672A964FB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0A5EF6-D393-4852-B656-5E6B74B3F5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DC8D45-B679-4E41-8BC4-4F6ED2D5BC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BD3521-1250-457F-9CD9-0B96729F30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DBC046-C279-4806-A7BD-B01D11F509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89C431-2892-493C-8BFD-912F42C500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664139-F436-4EBA-A040-7A3795CDC0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212DF3-F64B-4542-A068-F4EB67F467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3C09DD6-8FF3-45BB-9FCE-1A3DA4FBD584}" type="datetime">
              <a:rPr b="0" lang="zh-CN" sz="1400" spc="-1" strike="noStrike">
                <a:solidFill>
                  <a:srgbClr val="000000"/>
                </a:solidFill>
                <a:latin typeface="Arial"/>
              </a:rPr>
              <a:t>26/8/29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1950F07-0378-4694-88AB-4E9068C240ED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8" descr=""/>
          <p:cNvPicPr/>
          <p:nvPr/>
        </p:nvPicPr>
        <p:blipFill>
          <a:blip r:embed="rId1"/>
          <a:stretch/>
        </p:blipFill>
        <p:spPr>
          <a:xfrm>
            <a:off x="1133640" y="660240"/>
            <a:ext cx="6811920" cy="4656240"/>
          </a:xfrm>
          <a:prstGeom prst="rect">
            <a:avLst/>
          </a:prstGeom>
          <a:ln w="0">
            <a:noFill/>
          </a:ln>
        </p:spPr>
      </p:pic>
      <p:sp>
        <p:nvSpPr>
          <p:cNvPr id="42" name="矩形 5"/>
          <p:cNvSpPr/>
          <p:nvPr/>
        </p:nvSpPr>
        <p:spPr>
          <a:xfrm>
            <a:off x="6982200" y="4559400"/>
            <a:ext cx="688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△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at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O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矩形 5"/>
          <p:cNvSpPr/>
          <p:nvPr/>
        </p:nvSpPr>
        <p:spPr>
          <a:xfrm>
            <a:off x="5589720" y="2335320"/>
            <a:ext cx="2325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RJ71+pRJ4/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S. albus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J107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矩形 19"/>
          <p:cNvSpPr/>
          <p:nvPr/>
        </p:nvSpPr>
        <p:spPr>
          <a:xfrm>
            <a:off x="866880" y="5546880"/>
            <a:ext cx="73404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. S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. HPLC-MS analysis of the UAT-B production level from the reported strain pRJ71+pRJ4/J107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hich was generated as the heterologous expression system for producing UAT-B and NATs (</a:t>
            </a: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Shen et al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2020, </a:t>
            </a:r>
            <a:r>
              <a:rPr b="0" i="1" lang="nl-NL" sz="1200" spc="-1" strike="noStrike">
                <a:solidFill>
                  <a:srgbClr val="000000"/>
                </a:solidFill>
                <a:latin typeface="Arial"/>
              </a:rPr>
              <a:t>J Biol Chem </a:t>
            </a: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295(16):5509-5518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. The mutant strain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△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a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O generated in the work was used a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ontrol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e data are displayed with the mass extraction of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m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/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z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676.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, [M+Na]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for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UAT-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矩形 16"/>
          <p:cNvSpPr/>
          <p:nvPr/>
        </p:nvSpPr>
        <p:spPr>
          <a:xfrm>
            <a:off x="3666960" y="419040"/>
            <a:ext cx="67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200" spc="-1" strike="noStrike">
                <a:solidFill>
                  <a:srgbClr val="000000"/>
                </a:solidFill>
                <a:latin typeface="Arial"/>
              </a:rPr>
              <a:t>UAT-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2" descr=""/>
          <p:cNvPicPr/>
          <p:nvPr/>
        </p:nvPicPr>
        <p:blipFill>
          <a:blip r:embed="rId1"/>
          <a:srcRect l="0" t="0" r="0" b="30613"/>
          <a:stretch/>
        </p:blipFill>
        <p:spPr>
          <a:xfrm>
            <a:off x="1465200" y="376200"/>
            <a:ext cx="6340680" cy="3527640"/>
          </a:xfrm>
          <a:prstGeom prst="rect">
            <a:avLst/>
          </a:prstGeom>
          <a:ln w="0">
            <a:noFill/>
          </a:ln>
        </p:spPr>
      </p:pic>
      <p:sp>
        <p:nvSpPr>
          <p:cNvPr id="47" name="矩形 22"/>
          <p:cNvSpPr/>
          <p:nvPr/>
        </p:nvSpPr>
        <p:spPr>
          <a:xfrm>
            <a:off x="4729320" y="2876400"/>
            <a:ext cx="3125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kasO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*_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n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G-</a:t>
            </a:r>
            <a:r>
              <a:rPr b="1" i="1" lang="en-US" sz="1200" spc="-1" strike="noStrike">
                <a:solidFill>
                  <a:srgbClr val="0000cc"/>
                </a:solidFill>
                <a:latin typeface="Arial"/>
                <a:ea typeface="Arial"/>
              </a:rPr>
              <a:t>nat</a:t>
            </a:r>
            <a:r>
              <a:rPr b="1" lang="en-US" sz="1200" spc="-1" strike="noStrike">
                <a:solidFill>
                  <a:srgbClr val="0000cc"/>
                </a:solidFill>
                <a:latin typeface="Arial"/>
                <a:ea typeface="Arial"/>
              </a:rPr>
              <a:t>F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+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_nat-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hyg5/△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a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O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矩形 22"/>
          <p:cNvSpPr/>
          <p:nvPr/>
        </p:nvSpPr>
        <p:spPr>
          <a:xfrm>
            <a:off x="4721400" y="1947960"/>
            <a:ext cx="3235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kasO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*_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n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G-</a:t>
            </a:r>
            <a:r>
              <a:rPr b="1" i="1" lang="en-US" sz="1200" spc="-1" strike="noStrike">
                <a:solidFill>
                  <a:srgbClr val="c00000"/>
                </a:solidFill>
                <a:latin typeface="Arial"/>
                <a:ea typeface="Arial"/>
              </a:rPr>
              <a:t>ant</a:t>
            </a:r>
            <a:r>
              <a:rPr b="1" lang="en-US" sz="1200" spc="-1" strike="noStrike">
                <a:solidFill>
                  <a:srgbClr val="c00000"/>
                </a:solidFill>
                <a:latin typeface="Arial"/>
                <a:ea typeface="Arial"/>
              </a:rPr>
              <a:t>F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+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_nat-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hyg5/△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a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O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矩形 22"/>
          <p:cNvSpPr/>
          <p:nvPr/>
        </p:nvSpPr>
        <p:spPr>
          <a:xfrm>
            <a:off x="6189840" y="1062000"/>
            <a:ext cx="176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_nat-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hyg5/△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a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O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矩形 19"/>
          <p:cNvSpPr/>
          <p:nvPr/>
        </p:nvSpPr>
        <p:spPr>
          <a:xfrm>
            <a:off x="993600" y="4859280"/>
            <a:ext cx="739944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. S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. HPLC-MS analysis of the UAT-B production levels from the △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a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O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derivative strains, which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ndividually contained the plasmid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J253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_nat-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hyg5),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pRJ255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kasO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*_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n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G-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a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 +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_nat-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hyg5),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nd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J256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kasO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*_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n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G-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n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 +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_nat-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hyg5). The empty vector pRJ5 was used as negative control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e data are displayed with the mass extraction of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m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/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z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676.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, [M+Na]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for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UAT-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矩形 16"/>
          <p:cNvSpPr/>
          <p:nvPr/>
        </p:nvSpPr>
        <p:spPr>
          <a:xfrm>
            <a:off x="3710160" y="169920"/>
            <a:ext cx="677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200" spc="-1" strike="noStrike">
                <a:solidFill>
                  <a:srgbClr val="000000"/>
                </a:solidFill>
                <a:latin typeface="Arial"/>
              </a:rPr>
              <a:t>UAT-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Picture 2" descr=""/>
          <p:cNvPicPr/>
          <p:nvPr/>
        </p:nvPicPr>
        <p:blipFill>
          <a:blip r:embed="rId2"/>
          <a:srcRect l="0" t="86202" r="0" b="0"/>
          <a:stretch/>
        </p:blipFill>
        <p:spPr>
          <a:xfrm>
            <a:off x="1465200" y="3863880"/>
            <a:ext cx="6340680" cy="701640"/>
          </a:xfrm>
          <a:prstGeom prst="rect">
            <a:avLst/>
          </a:prstGeom>
          <a:ln w="0">
            <a:noFill/>
          </a:ln>
        </p:spPr>
      </p:pic>
      <p:sp>
        <p:nvSpPr>
          <p:cNvPr id="53" name="矩形 36"/>
          <p:cNvSpPr/>
          <p:nvPr/>
        </p:nvSpPr>
        <p:spPr>
          <a:xfrm>
            <a:off x="6272280" y="3816360"/>
            <a:ext cx="1636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mpty vector/△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a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O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9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25T01:44:32Z</dcterms:created>
  <dc:creator>think</dc:creator>
  <dc:description/>
  <dc:language>en-US</dc:language>
  <cp:lastModifiedBy>AutoBVT</cp:lastModifiedBy>
  <dcterms:modified xsi:type="dcterms:W3CDTF">2021-05-05T02:53:46Z</dcterms:modified>
  <cp:revision>471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9.1.0.4885</vt:lpwstr>
  </property>
</Properties>
</file>